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2" r:id="rId2"/>
  </p:sldIdLst>
  <p:sldSz cx="12192000" cy="1625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0000"/>
    <a:srgbClr val="000000"/>
    <a:srgbClr val="FBE5D6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7" d="100"/>
          <a:sy n="47" d="100"/>
        </p:scale>
        <p:origin x="3012" y="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086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9041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772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6191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7668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0787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47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6176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705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564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2992654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4A05F-7D26-4DF5-AAF3-375857C92025}" type="datetimeFigureOut">
              <a:rPr lang="en-GB" smtClean="0"/>
              <a:t>05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725F6-5540-4F95-9BE0-0D12C382A59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592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png"/>
   <Relationship Id="rId3" Type="http://schemas.openxmlformats.org/officeDocument/2006/relationships/image" Target="../media/image2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19034" t="11607" r="16123" b="12898"/>
          <a:stretch/>
        </p:blipFill>
        <p:spPr>
          <a:xfrm>
            <a:off x="1803510" y="1439913"/>
            <a:ext cx="3149490" cy="417668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9965" t="13181" r="11790" b="4152"/>
          <a:stretch/>
        </p:blipFill>
        <p:spPr>
          <a:xfrm>
            <a:off x="5688639" y="1439913"/>
            <a:ext cx="3749472" cy="41759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745567" y="766521"/>
            <a:ext cx="12653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tW</a:t>
            </a:r>
            <a:endParaRPr lang="en-GB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992506" y="766521"/>
            <a:ext cx="12653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tZ</a:t>
            </a:r>
            <a:endParaRPr lang="en-GB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41361" y="6349731"/>
            <a:ext cx="1120709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</a:t>
            </a:r>
            <a:r>
              <a:rPr lang="en-GB" sz="2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dence of the predictive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D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tructure 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CRTW and CRTZ. Protein modelling, prediction and analysis of the CRTW and CRTZ enzymes were obtained using the Phyre</a:t>
            </a:r>
            <a:r>
              <a:rPr lang="en-GB" sz="2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b portal (Kelley et al., 2015). The red colour shows the residues for which the confidence of the model is higher than 90%, otherwise it is in blue. 99</a:t>
            </a:r>
            <a:r>
              <a:rPr lang="en-GB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 and 81% of the residues were modelled at &gt; 90% of confidence for CRTW and CRTZ, </a:t>
            </a:r>
            <a:r>
              <a:rPr lang="en-GB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</a:t>
            </a:r>
          </a:p>
          <a:p>
            <a:endParaRPr lang="en-GB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5402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</TotalTime>
  <Words>93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